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12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7ED4D-C0FD-4B8A-936E-D52AADFC5592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F5E0C-949C-4D8D-A7E0-75E1D135CF2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14400" y="3810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524000" y="2685847"/>
          <a:ext cx="6096000" cy="1486305"/>
        </p:xfrm>
        <a:graphic>
          <a:graphicData uri="http://schemas.openxmlformats.org/drawingml/2006/table">
            <a:tbl>
              <a:tblPr/>
              <a:tblGrid>
                <a:gridCol w="387731"/>
                <a:gridCol w="538516"/>
                <a:gridCol w="592367"/>
                <a:gridCol w="430813"/>
                <a:gridCol w="430813"/>
                <a:gridCol w="430813"/>
                <a:gridCol w="646219"/>
                <a:gridCol w="753922"/>
                <a:gridCol w="538516"/>
                <a:gridCol w="1346290"/>
              </a:tblGrid>
              <a:tr h="330290">
                <a:tc gridSpan="10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Online Resource 2. </a:t>
                      </a:r>
                      <a:r>
                        <a:rPr lang="en-US" sz="900" i="1">
                          <a:latin typeface="Times New Roman"/>
                          <a:ea typeface="Calibri"/>
                        </a:rPr>
                        <a:t>Fot4-1</a:t>
                      </a:r>
                      <a:r>
                        <a:rPr lang="en-US" sz="900">
                          <a:latin typeface="Times New Roman"/>
                          <a:ea typeface="Calibri"/>
                        </a:rPr>
                        <a:t> in the IT93K-503-1 x CB46 population, the cowpea consensus genetic map and the cowpea physical map.  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5145">
                <a:tc grid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IT93K-503-1 x CB46 genetic map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Cowpea consensus genetic map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Cowpea physical map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514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LG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cM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SNP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LOD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R</a:t>
                      </a:r>
                      <a:r>
                        <a:rPr lang="en-US" sz="900" baseline="30000">
                          <a:latin typeface="Times New Roman"/>
                          <a:ea typeface="Calibri"/>
                        </a:rPr>
                        <a:t>2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LG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cM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SNP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contig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BAC clone(s)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14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8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8.86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055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6.42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8.8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5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1.5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055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N/A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14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8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35.21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1492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7.48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32.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5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5.13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1492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N/A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14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N/A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5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5.70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0662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7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CH095K15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14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N/A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5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5.70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0986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N/A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14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8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40.6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0030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5.98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7.1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5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29.40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1_0030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</a:rPr>
                        <a:t>417</a:t>
                      </a:r>
                      <a:endParaRPr lang="en-US" sz="110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Times New Roman"/>
                          <a:ea typeface="Calibri"/>
                        </a:rPr>
                        <a:t>CH027H24, CH035P21</a:t>
                      </a:r>
                      <a:endParaRPr lang="en-US" sz="1100" dirty="0">
                        <a:latin typeface="Times New Roman"/>
                        <a:ea typeface="Calibri"/>
                      </a:endParaRPr>
                    </a:p>
                  </a:txBody>
                  <a:tcPr marL="64622" marR="6462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0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18:44Z</dcterms:created>
  <dcterms:modified xsi:type="dcterms:W3CDTF">2013-11-13T12:19:47Z</dcterms:modified>
</cp:coreProperties>
</file>